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6858000" cy="9903460" type="A4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者" initials="A" lastIdx="0" clrIdx="1"/>
  <p:cmAuthor id="1" name="Administrator" initials="A" lastIdx="1" clrIdx="0"/>
  <p:cmAuthor id="3" name="lenovo" initials="l" lastIdx="6" clrIdx="2"/>
  <p:cmAuthor id="4" name="王习习" initials="王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commentAuthors" Target="commentAuthors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758"/>
            <a:ext cx="2901255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565"/>
            <a:ext cx="2901255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758"/>
            <a:ext cx="2915543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565"/>
            <a:ext cx="2915543" cy="532089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6.jpeg"/><Relationship Id="rId7" Type="http://schemas.openxmlformats.org/officeDocument/2006/relationships/image" Target="../media/image5.jpeg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emf"/><Relationship Id="rId10" Type="http://schemas.openxmlformats.org/officeDocument/2006/relationships/vmlDrawing" Target="../drawings/vmlDrawing1.vml"/><Relationship Id="rId1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6" name="文本框 75"/>
          <p:cNvSpPr txBox="1"/>
          <p:nvPr/>
        </p:nvSpPr>
        <p:spPr>
          <a:xfrm>
            <a:off x="0" y="0"/>
            <a:ext cx="18954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</a:t>
            </a: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entary Figure 1</a:t>
            </a:r>
            <a:endParaRPr kumimoji="0" lang="en-US" altLang="zh-CN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85" name="组合 84"/>
          <p:cNvGrpSpPr/>
          <p:nvPr/>
        </p:nvGrpSpPr>
        <p:grpSpPr>
          <a:xfrm>
            <a:off x="64770" y="455295"/>
            <a:ext cx="2005965" cy="1656715"/>
            <a:chOff x="4902" y="538"/>
            <a:chExt cx="3159" cy="2609"/>
          </a:xfrm>
        </p:grpSpPr>
        <p:graphicFrame>
          <p:nvGraphicFramePr>
            <p:cNvPr id="12" name="对象 11"/>
            <p:cNvGraphicFramePr>
              <a:graphicFrameLocks noChangeAspect="1"/>
            </p:cNvGraphicFramePr>
            <p:nvPr/>
          </p:nvGraphicFramePr>
          <p:xfrm>
            <a:off x="5351" y="538"/>
            <a:ext cx="2711" cy="24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" name="" r:id="rId1" imgW="3282950" imgH="2908300" progId="Prism9.Document">
                    <p:embed/>
                  </p:oleObj>
                </mc:Choice>
                <mc:Fallback>
                  <p:oleObj name="" r:id="rId1" imgW="3282950" imgH="2908300" progId="Prism9.Document">
                    <p:embed/>
                    <p:pic>
                      <p:nvPicPr>
                        <p:cNvPr id="0" name="图片 8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5351" y="538"/>
                          <a:ext cx="2711" cy="24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组合 3"/>
            <p:cNvGrpSpPr/>
            <p:nvPr/>
          </p:nvGrpSpPr>
          <p:grpSpPr>
            <a:xfrm rot="0">
              <a:off x="4902" y="2649"/>
              <a:ext cx="3018" cy="499"/>
              <a:chOff x="2405071" y="2369151"/>
              <a:chExt cx="1003776" cy="341321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2405071" y="2369151"/>
                <a:ext cx="432375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1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2436668" y="2462860"/>
                <a:ext cx="400779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EEF1G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2964189" y="2369151"/>
                <a:ext cx="210314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2852072" y="2369151"/>
                <a:ext cx="202299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3196785" y="2369151"/>
                <a:ext cx="210314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3079967" y="2462817"/>
                <a:ext cx="210314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3198533" y="2462817"/>
                <a:ext cx="210314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2853277" y="2462817"/>
                <a:ext cx="202299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2968197" y="2462817"/>
                <a:ext cx="202299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3085825" y="2369151"/>
                <a:ext cx="202299" cy="2476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86" name="组合 85"/>
          <p:cNvGrpSpPr/>
          <p:nvPr/>
        </p:nvGrpSpPr>
        <p:grpSpPr>
          <a:xfrm>
            <a:off x="1943100" y="446405"/>
            <a:ext cx="1960880" cy="1685925"/>
            <a:chOff x="7503" y="493"/>
            <a:chExt cx="3088" cy="2655"/>
          </a:xfrm>
        </p:grpSpPr>
        <p:graphicFrame>
          <p:nvGraphicFramePr>
            <p:cNvPr id="17" name="对象 16"/>
            <p:cNvGraphicFramePr>
              <a:graphicFrameLocks noChangeAspect="1"/>
            </p:cNvGraphicFramePr>
            <p:nvPr/>
          </p:nvGraphicFramePr>
          <p:xfrm>
            <a:off x="7915" y="493"/>
            <a:ext cx="2677" cy="24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" name="" r:id="rId3" imgW="3143250" imgH="2825750" progId="Prism9.Document">
                    <p:embed/>
                  </p:oleObj>
                </mc:Choice>
                <mc:Fallback>
                  <p:oleObj name="" r:id="rId3" imgW="3143250" imgH="2825750" progId="Prism9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915" y="493"/>
                          <a:ext cx="2677" cy="24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8" name="组合 17"/>
            <p:cNvGrpSpPr/>
            <p:nvPr/>
          </p:nvGrpSpPr>
          <p:grpSpPr>
            <a:xfrm rot="0">
              <a:off x="7503" y="2624"/>
              <a:ext cx="2960" cy="524"/>
              <a:chOff x="2443725" y="2352037"/>
              <a:chExt cx="965122" cy="358717"/>
            </a:xfrm>
          </p:grpSpPr>
          <p:sp>
            <p:nvSpPr>
              <p:cNvPr id="19" name="文本框 18"/>
              <p:cNvSpPr txBox="1"/>
              <p:nvPr/>
            </p:nvSpPr>
            <p:spPr>
              <a:xfrm>
                <a:off x="2468831" y="2352037"/>
                <a:ext cx="376593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YTHDF1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2443725" y="2462938"/>
                <a:ext cx="393548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EF1G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2964189" y="2369151"/>
                <a:ext cx="210314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2852072" y="2369151"/>
                <a:ext cx="202299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3196785" y="2369151"/>
                <a:ext cx="210314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3079967" y="2462817"/>
                <a:ext cx="210314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3198533" y="2462817"/>
                <a:ext cx="210314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2853277" y="2462817"/>
                <a:ext cx="202299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2968197" y="2462817"/>
                <a:ext cx="202299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3085825" y="2369151"/>
                <a:ext cx="202299" cy="247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87" name="组合 86"/>
          <p:cNvGrpSpPr/>
          <p:nvPr/>
        </p:nvGrpSpPr>
        <p:grpSpPr>
          <a:xfrm>
            <a:off x="3571240" y="457200"/>
            <a:ext cx="2823210" cy="1659890"/>
            <a:chOff x="6278" y="3148"/>
            <a:chExt cx="4446" cy="2614"/>
          </a:xfrm>
        </p:grpSpPr>
        <p:grpSp>
          <p:nvGrpSpPr>
            <p:cNvPr id="25" name="组合 24"/>
            <p:cNvGrpSpPr>
              <a:grpSpLocks noChangeAspect="1"/>
            </p:cNvGrpSpPr>
            <p:nvPr/>
          </p:nvGrpSpPr>
          <p:grpSpPr>
            <a:xfrm rot="0">
              <a:off x="6281" y="3565"/>
              <a:ext cx="3933" cy="815"/>
              <a:chOff x="7203" y="3260"/>
              <a:chExt cx="8656" cy="1724"/>
            </a:xfrm>
          </p:grpSpPr>
          <p:sp>
            <p:nvSpPr>
              <p:cNvPr id="29" name="文本框 28"/>
              <p:cNvSpPr txBox="1"/>
              <p:nvPr/>
            </p:nvSpPr>
            <p:spPr>
              <a:xfrm>
                <a:off x="7203" y="3260"/>
                <a:ext cx="4302" cy="1173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lIns="68580" tIns="34290" rIns="68580" bIns="34290" rtlCol="0">
                <a:noAutofit/>
              </a:bodyPr>
              <a:p>
                <a:pPr indent="539750" algn="l">
                  <a:lnSpc>
                    <a:spcPct val="150000"/>
                  </a:lnSpc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charset="-122"/>
                    <a:cs typeface="Times New Roman" panose="02020603050405020304" pitchFamily="18" charset="0"/>
                    <a:sym typeface="+mn-ea"/>
                  </a:rPr>
                  <a:t>YTHDF1</a:t>
                </a:r>
                <a:endPara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7387" y="4063"/>
                <a:ext cx="4143" cy="921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lIns="68580" tIns="34290" rIns="68580" bIns="34290" rtlCol="0">
                <a:spAutoFit/>
              </a:bodyPr>
              <a:p>
                <a:pPr indent="539750" algn="l">
                  <a:lnSpc>
                    <a:spcPct val="150000"/>
                  </a:lnSpc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charset="-122"/>
                    <a:cs typeface="Times New Roman" panose="02020603050405020304" pitchFamily="18" charset="0"/>
                    <a:sym typeface="+mn-ea"/>
                  </a:rPr>
                  <a:t>GAPDH</a:t>
                </a:r>
                <a:endPara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endParaRPr>
              </a:p>
            </p:txBody>
          </p:sp>
          <p:pic>
            <p:nvPicPr>
              <p:cNvPr id="31" name="图片 30" descr="20240621-549-gpdh2"/>
              <p:cNvPicPr/>
              <p:nvPr/>
            </p:nvPicPr>
            <p:blipFill>
              <a:blip r:embed="rId5">
                <a:lum bright="-12000" contrast="78000"/>
              </a:blip>
              <a:srcRect l="14711" t="11010" r="12212" b="47690"/>
              <a:stretch>
                <a:fillRect/>
              </a:stretch>
            </p:blipFill>
            <p:spPr>
              <a:xfrm>
                <a:off x="11308" y="4297"/>
                <a:ext cx="4549" cy="6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2" name="图片 31" descr="20240621-549-y3"/>
              <p:cNvPicPr/>
              <p:nvPr/>
            </p:nvPicPr>
            <p:blipFill>
              <a:blip r:embed="rId6">
                <a:lum bright="24000" contrast="60000"/>
              </a:blip>
              <a:srcRect l="15914" t="30487" r="18082" b="40778"/>
              <a:stretch>
                <a:fillRect/>
              </a:stretch>
            </p:blipFill>
            <p:spPr>
              <a:xfrm>
                <a:off x="11305" y="3394"/>
                <a:ext cx="4554" cy="6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3" name="组合 22"/>
            <p:cNvGrpSpPr>
              <a:grpSpLocks noChangeAspect="1"/>
            </p:cNvGrpSpPr>
            <p:nvPr/>
          </p:nvGrpSpPr>
          <p:grpSpPr>
            <a:xfrm>
              <a:off x="6278" y="4946"/>
              <a:ext cx="3943" cy="817"/>
              <a:chOff x="7998" y="7762"/>
              <a:chExt cx="5768" cy="1185"/>
            </a:xfrm>
          </p:grpSpPr>
          <p:sp>
            <p:nvSpPr>
              <p:cNvPr id="33" name="文本框 32"/>
              <p:cNvSpPr txBox="1"/>
              <p:nvPr/>
            </p:nvSpPr>
            <p:spPr>
              <a:xfrm>
                <a:off x="7998" y="7762"/>
                <a:ext cx="2765" cy="756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lIns="68580" tIns="34290" rIns="68580" bIns="34290" rtlCol="0">
                <a:noAutofit/>
              </a:bodyPr>
              <a:p>
                <a:pPr indent="539750" algn="l">
                  <a:lnSpc>
                    <a:spcPct val="150000"/>
                  </a:lnSpc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charset="-122"/>
                    <a:cs typeface="Times New Roman" panose="02020603050405020304" pitchFamily="18" charset="0"/>
                    <a:sym typeface="+mn-ea"/>
                  </a:rPr>
                  <a:t>YTHDF1</a:t>
                </a:r>
                <a:endPara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8109" y="8316"/>
                <a:ext cx="2654" cy="631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lIns="68580" tIns="34290" rIns="68580" bIns="34290" rtlCol="0">
                <a:spAutoFit/>
              </a:bodyPr>
              <a:p>
                <a:pPr indent="539750" algn="l">
                  <a:lnSpc>
                    <a:spcPct val="150000"/>
                  </a:lnSpc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charset="-122"/>
                    <a:cs typeface="Times New Roman" panose="02020603050405020304" pitchFamily="18" charset="0"/>
                    <a:sym typeface="+mn-ea"/>
                  </a:rPr>
                  <a:t>GAPDH</a:t>
                </a:r>
                <a:endPara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endParaRPr>
              </a:p>
            </p:txBody>
          </p:sp>
          <p:grpSp>
            <p:nvGrpSpPr>
              <p:cNvPr id="36" name="组合 35"/>
              <p:cNvGrpSpPr/>
              <p:nvPr/>
            </p:nvGrpSpPr>
            <p:grpSpPr>
              <a:xfrm rot="0">
                <a:off x="10738" y="7859"/>
                <a:ext cx="3028" cy="1076"/>
                <a:chOff x="9980" y="3754"/>
                <a:chExt cx="3028" cy="1076"/>
              </a:xfrm>
            </p:grpSpPr>
            <p:pic>
              <p:nvPicPr>
                <p:cNvPr id="39" name="图片 38" descr="20240613-rescue-2"/>
                <p:cNvPicPr>
                  <a:picLocks noChangeAspect="1"/>
                </p:cNvPicPr>
                <p:nvPr/>
              </p:nvPicPr>
              <p:blipFill>
                <a:blip r:embed="rId7">
                  <a:lum bright="-30000" contrast="66000"/>
                </a:blip>
                <a:srcRect l="51641" t="62918" r="5523" b="11541"/>
                <a:stretch>
                  <a:fillRect/>
                </a:stretch>
              </p:blipFill>
              <p:spPr>
                <a:xfrm>
                  <a:off x="9980" y="4385"/>
                  <a:ext cx="3028" cy="44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0" name="图片 39" descr="20240609ythdf1-1975-2"/>
                <p:cNvPicPr>
                  <a:picLocks noChangeAspect="1"/>
                </p:cNvPicPr>
                <p:nvPr/>
              </p:nvPicPr>
              <p:blipFill>
                <a:blip r:embed="rId8">
                  <a:lum bright="-6000" contrast="12000"/>
                </a:blip>
                <a:srcRect l="14327" t="5287" r="37428" b="65915"/>
                <a:stretch>
                  <a:fillRect/>
                </a:stretch>
              </p:blipFill>
              <p:spPr>
                <a:xfrm>
                  <a:off x="9981" y="3754"/>
                  <a:ext cx="3027" cy="448"/>
                </a:xfrm>
                <a:prstGeom prst="rect">
                  <a:avLst/>
                </a:prstGeom>
                <a:ln>
                  <a:solidFill>
                    <a:srgbClr val="282828"/>
                  </a:solidFill>
                </a:ln>
              </p:spPr>
            </p:pic>
          </p:grpSp>
        </p:grpSp>
        <p:grpSp>
          <p:nvGrpSpPr>
            <p:cNvPr id="41" name="组合 40"/>
            <p:cNvGrpSpPr/>
            <p:nvPr/>
          </p:nvGrpSpPr>
          <p:grpSpPr>
            <a:xfrm rot="0">
              <a:off x="6610" y="4517"/>
              <a:ext cx="4115" cy="566"/>
              <a:chOff x="2485676" y="2369151"/>
              <a:chExt cx="923171" cy="260456"/>
            </a:xfrm>
          </p:grpSpPr>
          <p:sp>
            <p:nvSpPr>
              <p:cNvPr id="42" name="文本框 41"/>
              <p:cNvSpPr txBox="1"/>
              <p:nvPr/>
            </p:nvSpPr>
            <p:spPr>
              <a:xfrm>
                <a:off x="2485676" y="2369151"/>
                <a:ext cx="331355" cy="24583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YTHDF1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2544297" y="2462988"/>
                <a:ext cx="273234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EF1G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文本框 329"/>
              <p:cNvSpPr txBox="1"/>
              <p:nvPr/>
            </p:nvSpPr>
            <p:spPr>
              <a:xfrm>
                <a:off x="2964189" y="2369151"/>
                <a:ext cx="210314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31" name="文本框 330"/>
              <p:cNvSpPr txBox="1"/>
              <p:nvPr/>
            </p:nvSpPr>
            <p:spPr>
              <a:xfrm>
                <a:off x="2852072" y="2369151"/>
                <a:ext cx="202299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文本框 331"/>
              <p:cNvSpPr txBox="1"/>
              <p:nvPr/>
            </p:nvSpPr>
            <p:spPr>
              <a:xfrm>
                <a:off x="3196785" y="2369151"/>
                <a:ext cx="210314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33" name="文本框 332"/>
              <p:cNvSpPr txBox="1"/>
              <p:nvPr/>
            </p:nvSpPr>
            <p:spPr>
              <a:xfrm>
                <a:off x="3079967" y="2462817"/>
                <a:ext cx="210314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34" name="文本框 333"/>
              <p:cNvSpPr txBox="1"/>
              <p:nvPr/>
            </p:nvSpPr>
            <p:spPr>
              <a:xfrm>
                <a:off x="3198533" y="2462817"/>
                <a:ext cx="210314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35" name="文本框 334"/>
              <p:cNvSpPr txBox="1"/>
              <p:nvPr/>
            </p:nvSpPr>
            <p:spPr>
              <a:xfrm>
                <a:off x="2853277" y="2462817"/>
                <a:ext cx="202299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文本框 335"/>
              <p:cNvSpPr txBox="1"/>
              <p:nvPr/>
            </p:nvSpPr>
            <p:spPr>
              <a:xfrm>
                <a:off x="2968197" y="2462817"/>
                <a:ext cx="202299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文本框 336"/>
              <p:cNvSpPr txBox="1"/>
              <p:nvPr/>
            </p:nvSpPr>
            <p:spPr>
              <a:xfrm>
                <a:off x="3085825" y="2369151"/>
                <a:ext cx="202299" cy="16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38" name="组合 337"/>
            <p:cNvGrpSpPr/>
            <p:nvPr/>
          </p:nvGrpSpPr>
          <p:grpSpPr>
            <a:xfrm rot="0">
              <a:off x="6595" y="3148"/>
              <a:ext cx="4113" cy="565"/>
              <a:chOff x="2486125" y="2369151"/>
              <a:chExt cx="922722" cy="261015"/>
            </a:xfrm>
          </p:grpSpPr>
          <p:sp>
            <p:nvSpPr>
              <p:cNvPr id="339" name="文本框 338"/>
              <p:cNvSpPr txBox="1"/>
              <p:nvPr/>
            </p:nvSpPr>
            <p:spPr>
              <a:xfrm>
                <a:off x="2486125" y="2369152"/>
                <a:ext cx="331355" cy="24583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THDF1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文本框 339"/>
              <p:cNvSpPr txBox="1"/>
              <p:nvPr/>
            </p:nvSpPr>
            <p:spPr>
              <a:xfrm>
                <a:off x="2544297" y="2462988"/>
                <a:ext cx="273234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EEF1G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文本框 340"/>
              <p:cNvSpPr txBox="1"/>
              <p:nvPr/>
            </p:nvSpPr>
            <p:spPr>
              <a:xfrm>
                <a:off x="2964189" y="2369151"/>
                <a:ext cx="210314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42" name="文本框 341"/>
              <p:cNvSpPr txBox="1"/>
              <p:nvPr/>
            </p:nvSpPr>
            <p:spPr>
              <a:xfrm>
                <a:off x="2852072" y="2369151"/>
                <a:ext cx="202299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文本框 342"/>
              <p:cNvSpPr txBox="1"/>
              <p:nvPr/>
            </p:nvSpPr>
            <p:spPr>
              <a:xfrm>
                <a:off x="3196785" y="2369151"/>
                <a:ext cx="210314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44" name="文本框 343"/>
              <p:cNvSpPr txBox="1"/>
              <p:nvPr/>
            </p:nvSpPr>
            <p:spPr>
              <a:xfrm>
                <a:off x="3079967" y="2462817"/>
                <a:ext cx="210314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45" name="文本框 344"/>
              <p:cNvSpPr txBox="1"/>
              <p:nvPr/>
            </p:nvSpPr>
            <p:spPr>
              <a:xfrm>
                <a:off x="3198533" y="2462817"/>
                <a:ext cx="210314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/>
                  <a:t>+</a:t>
                </a:r>
                <a:endParaRPr lang="en-US" altLang="zh-CN" sz="900" b="1" dirty="0"/>
              </a:p>
            </p:txBody>
          </p:sp>
          <p:sp>
            <p:nvSpPr>
              <p:cNvPr id="346" name="文本框 345"/>
              <p:cNvSpPr txBox="1"/>
              <p:nvPr/>
            </p:nvSpPr>
            <p:spPr>
              <a:xfrm>
                <a:off x="2853277" y="2462817"/>
                <a:ext cx="202299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7" name="文本框 346"/>
              <p:cNvSpPr txBox="1"/>
              <p:nvPr/>
            </p:nvSpPr>
            <p:spPr>
              <a:xfrm>
                <a:off x="2968197" y="2462817"/>
                <a:ext cx="202299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8" name="文本框 347"/>
              <p:cNvSpPr txBox="1"/>
              <p:nvPr/>
            </p:nvSpPr>
            <p:spPr>
              <a:xfrm>
                <a:off x="3085825" y="2369151"/>
                <a:ext cx="202299" cy="1671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93" name="文本框 192"/>
          <p:cNvSpPr txBox="1"/>
          <p:nvPr/>
        </p:nvSpPr>
        <p:spPr>
          <a:xfrm>
            <a:off x="122555" y="415925"/>
            <a:ext cx="387350" cy="3321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978025" y="415925"/>
            <a:ext cx="475615" cy="3321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626485" y="415925"/>
            <a:ext cx="387350" cy="3321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JiY2FjN2Q1OTQ0Zjc4MjEzOGFhOGE2OWY4ZjhkM2E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WPS 演示</Application>
  <PresentationFormat>宽屏</PresentationFormat>
  <Paragraphs>96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等线</vt:lpstr>
      <vt:lpstr>微软雅黑</vt:lpstr>
      <vt:lpstr>Times New Roman</vt:lpstr>
      <vt:lpstr>Calibri</vt:lpstr>
      <vt:lpstr>Arial Unicode MS</vt:lpstr>
      <vt:lpstr>WPS</vt:lpstr>
      <vt:lpstr>Prism9.Document</vt:lpstr>
      <vt:lpstr>Prism9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盛琪宏</dc:creator>
  <cp:lastModifiedBy>Midsumner</cp:lastModifiedBy>
  <cp:revision>6</cp:revision>
  <dcterms:created xsi:type="dcterms:W3CDTF">2023-08-09T12:44:00Z</dcterms:created>
  <dcterms:modified xsi:type="dcterms:W3CDTF">2024-09-12T12:33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8240</vt:lpwstr>
  </property>
</Properties>
</file>